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6" autoAdjust="0"/>
    <p:restoredTop sz="94660"/>
  </p:normalViewPr>
  <p:slideViewPr>
    <p:cSldViewPr snapToGrid="0">
      <p:cViewPr varScale="1">
        <p:scale>
          <a:sx n="88" d="100"/>
          <a:sy n="88" d="100"/>
        </p:scale>
        <p:origin x="120" y="5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5EF146-EF89-4A7E-B606-E15B5A167F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B7D0789-45A7-465A-B4FF-BF67C01B9B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ko-KR"/>
              <a:t>Click to edit Master subtitle style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8D4437-6016-40D5-8B31-F290B739FC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287AA-4656-41A6-A02D-AC4601A93989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2F424F-B115-45F8-8447-9734466FA2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D4D62C-E82F-4AA8-B084-4D126342D4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4991-2D09-4A94-944C-10E4488A07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35914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1CC7F2-E1FD-4F92-83C6-2EF4D0A6C4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171044-DFCF-488F-B9DB-D82575F304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9E358C-0938-4C50-83AC-84A100F8E6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287AA-4656-41A6-A02D-AC4601A93989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FF228A-6611-4E62-B835-CAFA5E991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06A0D6-5F7B-4813-B99D-4EBB031759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4991-2D09-4A94-944C-10E4488A07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11515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ECF8B64-5061-4399-B3C5-3E4579395F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F92D1EE-2A83-474D-BE5A-FE8310141E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A8499D-EE70-4617-825D-32BD109A12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287AA-4656-41A6-A02D-AC4601A93989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0FFFAE-072B-4B75-998B-EE0E1A90DB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BEA0EF-406A-40A5-B454-BAAD61E856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4991-2D09-4A94-944C-10E4488A07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16707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236E0B-5CE7-4C03-998C-671D7B7462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2291E7-B4BE-4CE4-88BE-D7B305A7232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50731D-B4B6-4745-8A63-D5E3C8B4B3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287AA-4656-41A6-A02D-AC4601A93989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2F3377-0479-431A-A397-9F803B602C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AD53B6-63EA-46A3-A607-CC445799BD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4991-2D09-4A94-944C-10E4488A07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23641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92B4D3-0F28-49F5-9082-E02D8BC2F2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E0A262-0AB1-4476-8580-FFA33444E6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E2DA5D-426B-467A-A942-4F857FDA81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287AA-4656-41A6-A02D-AC4601A93989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81535E-A6BE-45F0-99E1-6F1072889C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400949-E814-4B18-80FC-BB2E7328C5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4991-2D09-4A94-944C-10E4488A07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77288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330C34-A4C5-4E55-81DB-AC737767A9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A9FB63-F081-4863-AFD9-104E9CF5DF2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607314-CB9C-4625-AE64-7DE969FBC7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600DF7-B344-4A01-A17A-C30CA737D5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287AA-4656-41A6-A02D-AC4601A93989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63AEFF-0037-43A2-8C86-17D946D88C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29D8BC-5760-41D9-852C-C11447E14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4991-2D09-4A94-944C-10E4488A07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104873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96FC72-4723-45FD-9E6A-F1ED2ED0F8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30F257-DB7A-49DC-84E5-F3CD18A710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872233-D765-446B-AF1E-14ADE6EC86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A9C0632-DB70-4304-9909-53D5705C4E5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61DEEEC-D778-44A1-AB70-A303F9B85D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C8F0B8F-3B11-41ED-AB96-67D6C3F71B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287AA-4656-41A6-A02D-AC4601A93989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D28A795-49A1-4648-9390-66D574A3D7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5C725E1-9F52-4640-95C0-4A68EB23AA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4991-2D09-4A94-944C-10E4488A07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3679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71F5C7-7B84-4C6F-B105-5EE5148F8B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4507759-907C-45D8-94D0-B6581CBC29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287AA-4656-41A6-A02D-AC4601A93989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22CFFEB-E95A-4880-B3B8-E02B04579C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5D7BC33-E8B9-49A1-A1A3-ABD532341F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4991-2D09-4A94-944C-10E4488A07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4221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B901B81-CE5F-449D-8680-602D61938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287AA-4656-41A6-A02D-AC4601A93989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FF52AE2-46F8-46A1-8847-09BC21FA12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E33110D-85D7-4DE8-899B-7D1AF47AC8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4991-2D09-4A94-944C-10E4488A07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39261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24FF28-257B-421A-ABFF-734F4B1390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57E7A5-88D4-4E98-8A0D-0D9B85750E4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2F6197E-A5CD-4388-A432-892D98B7AA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A3B203-36B4-4EA7-9581-5BFA6136DE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287AA-4656-41A6-A02D-AC4601A93989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7D7FED-C673-4B91-B5DF-D7B7129901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CB4549-620E-47D2-B395-E5A59BBD39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4991-2D09-4A94-944C-10E4488A07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3206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F0EFAF-06DF-4285-A1E4-16DB7831FB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2EF06C8-5B4C-4456-B1F2-A3B91CDF73A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69BF46A-1BC6-4473-BF44-8CECFE96F3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1B4DD2-4CD5-4A69-AA5C-DCC61505A7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C287AA-4656-41A6-A02D-AC4601A93989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B3E0C3-74B5-4D90-AFC4-4D074F0EA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9B6087-29E4-4F17-8E5C-69F28D6AE4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34991-2D09-4A94-944C-10E4488A07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2989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B6E0A6B-83CC-4617-8037-BBA673A376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/>
              <a:t>Click to edit Master title style</a:t>
            </a:r>
            <a:endParaRPr lang="ko-KR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28E964-8B4E-4B2A-B90C-6C57AB89C8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68B26F-F5DE-45E7-B572-B80B6558DBC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287AA-4656-41A6-A02D-AC4601A93989}" type="datetimeFigureOut">
              <a:rPr lang="ko-KR" altLang="en-US" smtClean="0"/>
              <a:t>2022-01-27</a:t>
            </a:fld>
            <a:endParaRPr lang="ko-KR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DD1D45-857D-41A1-ABF5-A848889B2F1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3D6B23-50C7-401D-9A4F-53203A24E89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834991-2D09-4A94-944C-10E4488A07D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206061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E5D3F852-3243-4843-9941-D3570792C24A}"/>
              </a:ext>
            </a:extLst>
          </p:cNvPr>
          <p:cNvSpPr txBox="1"/>
          <p:nvPr/>
        </p:nvSpPr>
        <p:spPr>
          <a:xfrm>
            <a:off x="754881" y="5514204"/>
            <a:ext cx="108783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.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luence analysis of the average daily gain (ADG) data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ults were computed by omitting each study (left) and informed on the right. The green interval represents the 95% confidence interval for the pooled effect size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45C33B3B-6862-4F77-87DF-FB79400853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026" y="979754"/>
            <a:ext cx="5863436" cy="442591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AE45824-31CF-4C8E-B8EB-E3B80B68AA2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34100" y="979754"/>
            <a:ext cx="5863436" cy="44259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10969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rea</dc:creator>
  <cp:lastModifiedBy>korea</cp:lastModifiedBy>
  <cp:revision>3</cp:revision>
  <dcterms:created xsi:type="dcterms:W3CDTF">2021-12-20T08:02:59Z</dcterms:created>
  <dcterms:modified xsi:type="dcterms:W3CDTF">2022-01-27T08:46:49Z</dcterms:modified>
</cp:coreProperties>
</file>